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中野 靖久" userId="c7a93b53d2a9f62f" providerId="LiveId" clId="{C9218AA2-7B21-44BC-A657-65E6222C8EC5}"/>
    <pc:docChg chg="custSel modSld">
      <pc:chgData name="中野 靖久" userId="c7a93b53d2a9f62f" providerId="LiveId" clId="{C9218AA2-7B21-44BC-A657-65E6222C8EC5}" dt="2021-06-07T12:15:33.294" v="139" actId="20577"/>
      <pc:docMkLst>
        <pc:docMk/>
      </pc:docMkLst>
      <pc:sldChg chg="modSp mod">
        <pc:chgData name="中野 靖久" userId="c7a93b53d2a9f62f" providerId="LiveId" clId="{C9218AA2-7B21-44BC-A657-65E6222C8EC5}" dt="2021-06-07T12:15:33.294" v="139" actId="20577"/>
        <pc:sldMkLst>
          <pc:docMk/>
          <pc:sldMk cId="4267744178" sldId="256"/>
        </pc:sldMkLst>
        <pc:spChg chg="mod">
          <ac:chgData name="中野 靖久" userId="c7a93b53d2a9f62f" providerId="LiveId" clId="{C9218AA2-7B21-44BC-A657-65E6222C8EC5}" dt="2021-06-07T12:15:33.294" v="139" actId="20577"/>
          <ac:spMkLst>
            <pc:docMk/>
            <pc:sldMk cId="4267744178" sldId="256"/>
            <ac:spMk id="5" creationId="{0B5E0920-5860-43C3-8E2A-CD4F6F100F09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c7a93b53d2a9f62f/&#12487;&#12473;&#12463;&#12488;&#12483;&#12503;/&#34220;&#23616;&#30740;&#31350;&#12394;&#12393;/nakano&#35542;&#25991;&#20316;&#25104;&#29992;/nakano%20&#20316;&#25104;&#20013;/&#23798;&#26681;&#30476;&#12467;&#12525;&#12490;&#29366;&#2784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104077028655228E-2"/>
          <c:y val="0.12278762595464499"/>
          <c:w val="0.893942622226786"/>
          <c:h val="0.625118745197275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[島根県コロナ状況.xlsx]Sheet2!$A$3:$A$99</c:f>
              <c:numCache>
                <c:formatCode>m/d;@</c:formatCode>
                <c:ptCount val="97"/>
                <c:pt idx="0">
                  <c:v>44126</c:v>
                </c:pt>
                <c:pt idx="1">
                  <c:v>44127</c:v>
                </c:pt>
                <c:pt idx="2">
                  <c:v>44128</c:v>
                </c:pt>
                <c:pt idx="3">
                  <c:v>44129</c:v>
                </c:pt>
                <c:pt idx="4">
                  <c:v>44130</c:v>
                </c:pt>
                <c:pt idx="5">
                  <c:v>44131</c:v>
                </c:pt>
                <c:pt idx="6">
                  <c:v>44132</c:v>
                </c:pt>
                <c:pt idx="7">
                  <c:v>44133</c:v>
                </c:pt>
                <c:pt idx="8">
                  <c:v>44134</c:v>
                </c:pt>
                <c:pt idx="9">
                  <c:v>44135</c:v>
                </c:pt>
                <c:pt idx="10">
                  <c:v>44501</c:v>
                </c:pt>
                <c:pt idx="11">
                  <c:v>44502</c:v>
                </c:pt>
                <c:pt idx="12">
                  <c:v>44503</c:v>
                </c:pt>
                <c:pt idx="13">
                  <c:v>44504</c:v>
                </c:pt>
                <c:pt idx="14">
                  <c:v>44505</c:v>
                </c:pt>
                <c:pt idx="15">
                  <c:v>44506</c:v>
                </c:pt>
                <c:pt idx="16">
                  <c:v>44507</c:v>
                </c:pt>
                <c:pt idx="17">
                  <c:v>44508</c:v>
                </c:pt>
                <c:pt idx="18">
                  <c:v>44509</c:v>
                </c:pt>
                <c:pt idx="19">
                  <c:v>44510</c:v>
                </c:pt>
                <c:pt idx="20">
                  <c:v>44511</c:v>
                </c:pt>
                <c:pt idx="21">
                  <c:v>44512</c:v>
                </c:pt>
                <c:pt idx="22">
                  <c:v>44513</c:v>
                </c:pt>
                <c:pt idx="23">
                  <c:v>44514</c:v>
                </c:pt>
                <c:pt idx="24">
                  <c:v>44515</c:v>
                </c:pt>
                <c:pt idx="25">
                  <c:v>44516</c:v>
                </c:pt>
                <c:pt idx="26">
                  <c:v>44517</c:v>
                </c:pt>
                <c:pt idx="27">
                  <c:v>44518</c:v>
                </c:pt>
                <c:pt idx="28">
                  <c:v>44519</c:v>
                </c:pt>
                <c:pt idx="29">
                  <c:v>44520</c:v>
                </c:pt>
                <c:pt idx="30">
                  <c:v>44521</c:v>
                </c:pt>
                <c:pt idx="31">
                  <c:v>44522</c:v>
                </c:pt>
                <c:pt idx="32">
                  <c:v>44523</c:v>
                </c:pt>
                <c:pt idx="33">
                  <c:v>44524</c:v>
                </c:pt>
                <c:pt idx="34">
                  <c:v>44525</c:v>
                </c:pt>
                <c:pt idx="35">
                  <c:v>44526</c:v>
                </c:pt>
                <c:pt idx="36">
                  <c:v>44527</c:v>
                </c:pt>
                <c:pt idx="37">
                  <c:v>44528</c:v>
                </c:pt>
                <c:pt idx="38">
                  <c:v>44529</c:v>
                </c:pt>
                <c:pt idx="39">
                  <c:v>44530</c:v>
                </c:pt>
                <c:pt idx="40">
                  <c:v>44166</c:v>
                </c:pt>
                <c:pt idx="41">
                  <c:v>44167</c:v>
                </c:pt>
                <c:pt idx="42">
                  <c:v>44168</c:v>
                </c:pt>
                <c:pt idx="43">
                  <c:v>44169</c:v>
                </c:pt>
                <c:pt idx="44">
                  <c:v>44170</c:v>
                </c:pt>
                <c:pt idx="45">
                  <c:v>44171</c:v>
                </c:pt>
                <c:pt idx="46">
                  <c:v>44172</c:v>
                </c:pt>
                <c:pt idx="47">
                  <c:v>44173</c:v>
                </c:pt>
                <c:pt idx="48">
                  <c:v>44174</c:v>
                </c:pt>
                <c:pt idx="49">
                  <c:v>44175</c:v>
                </c:pt>
                <c:pt idx="50">
                  <c:v>44176</c:v>
                </c:pt>
                <c:pt idx="51">
                  <c:v>44177</c:v>
                </c:pt>
                <c:pt idx="52">
                  <c:v>44178</c:v>
                </c:pt>
                <c:pt idx="53">
                  <c:v>44179</c:v>
                </c:pt>
                <c:pt idx="54">
                  <c:v>44180</c:v>
                </c:pt>
                <c:pt idx="55">
                  <c:v>44181</c:v>
                </c:pt>
                <c:pt idx="56">
                  <c:v>44182</c:v>
                </c:pt>
                <c:pt idx="57">
                  <c:v>44183</c:v>
                </c:pt>
                <c:pt idx="58">
                  <c:v>44184</c:v>
                </c:pt>
                <c:pt idx="59">
                  <c:v>44185</c:v>
                </c:pt>
                <c:pt idx="60">
                  <c:v>44186</c:v>
                </c:pt>
                <c:pt idx="61">
                  <c:v>44187</c:v>
                </c:pt>
                <c:pt idx="62">
                  <c:v>44188</c:v>
                </c:pt>
                <c:pt idx="63">
                  <c:v>44189</c:v>
                </c:pt>
                <c:pt idx="64">
                  <c:v>44190</c:v>
                </c:pt>
                <c:pt idx="65">
                  <c:v>44191</c:v>
                </c:pt>
                <c:pt idx="66">
                  <c:v>44192</c:v>
                </c:pt>
                <c:pt idx="67">
                  <c:v>44193</c:v>
                </c:pt>
                <c:pt idx="68">
                  <c:v>44194</c:v>
                </c:pt>
                <c:pt idx="69">
                  <c:v>44195</c:v>
                </c:pt>
                <c:pt idx="70">
                  <c:v>44196</c:v>
                </c:pt>
                <c:pt idx="71">
                  <c:v>44197</c:v>
                </c:pt>
                <c:pt idx="72">
                  <c:v>44198</c:v>
                </c:pt>
                <c:pt idx="73">
                  <c:v>44199</c:v>
                </c:pt>
                <c:pt idx="74">
                  <c:v>44200</c:v>
                </c:pt>
                <c:pt idx="75">
                  <c:v>44201</c:v>
                </c:pt>
                <c:pt idx="76">
                  <c:v>44202</c:v>
                </c:pt>
                <c:pt idx="77">
                  <c:v>44203</c:v>
                </c:pt>
                <c:pt idx="78">
                  <c:v>44204</c:v>
                </c:pt>
                <c:pt idx="79">
                  <c:v>44205</c:v>
                </c:pt>
                <c:pt idx="80">
                  <c:v>44206</c:v>
                </c:pt>
                <c:pt idx="81">
                  <c:v>44207</c:v>
                </c:pt>
                <c:pt idx="82">
                  <c:v>44208</c:v>
                </c:pt>
                <c:pt idx="83">
                  <c:v>44209</c:v>
                </c:pt>
                <c:pt idx="84">
                  <c:v>44210</c:v>
                </c:pt>
                <c:pt idx="85">
                  <c:v>44211</c:v>
                </c:pt>
                <c:pt idx="86">
                  <c:v>44212</c:v>
                </c:pt>
                <c:pt idx="87">
                  <c:v>44213</c:v>
                </c:pt>
                <c:pt idx="88">
                  <c:v>44214</c:v>
                </c:pt>
                <c:pt idx="89">
                  <c:v>44215</c:v>
                </c:pt>
                <c:pt idx="90">
                  <c:v>44216</c:v>
                </c:pt>
                <c:pt idx="91">
                  <c:v>44217</c:v>
                </c:pt>
                <c:pt idx="92">
                  <c:v>44218</c:v>
                </c:pt>
                <c:pt idx="93">
                  <c:v>44219</c:v>
                </c:pt>
                <c:pt idx="94">
                  <c:v>44220</c:v>
                </c:pt>
                <c:pt idx="95">
                  <c:v>44221</c:v>
                </c:pt>
                <c:pt idx="96">
                  <c:v>44222</c:v>
                </c:pt>
              </c:numCache>
            </c:numRef>
          </c:cat>
          <c:val>
            <c:numRef>
              <c:f>[島根県コロナ状況.xlsx]Sheet2!$B$3:$B$99</c:f>
              <c:numCache>
                <c:formatCode>General</c:formatCode>
                <c:ptCount val="9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2</c:v>
                </c:pt>
                <c:pt idx="46">
                  <c:v>1</c:v>
                </c:pt>
                <c:pt idx="47">
                  <c:v>0</c:v>
                </c:pt>
                <c:pt idx="48">
                  <c:v>0</c:v>
                </c:pt>
                <c:pt idx="49">
                  <c:v>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</c:v>
                </c:pt>
                <c:pt idx="54">
                  <c:v>0</c:v>
                </c:pt>
                <c:pt idx="55">
                  <c:v>2</c:v>
                </c:pt>
                <c:pt idx="56">
                  <c:v>4</c:v>
                </c:pt>
                <c:pt idx="57">
                  <c:v>4</c:v>
                </c:pt>
                <c:pt idx="58">
                  <c:v>1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1</c:v>
                </c:pt>
                <c:pt idx="64">
                  <c:v>0</c:v>
                </c:pt>
                <c:pt idx="65">
                  <c:v>2</c:v>
                </c:pt>
                <c:pt idx="66">
                  <c:v>1</c:v>
                </c:pt>
                <c:pt idx="67">
                  <c:v>0</c:v>
                </c:pt>
                <c:pt idx="68">
                  <c:v>1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1</c:v>
                </c:pt>
                <c:pt idx="77">
                  <c:v>1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2</c:v>
                </c:pt>
                <c:pt idx="85">
                  <c:v>0</c:v>
                </c:pt>
                <c:pt idx="86">
                  <c:v>0</c:v>
                </c:pt>
                <c:pt idx="87">
                  <c:v>1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2B-448A-99F1-284D62B239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41413696"/>
        <c:axId val="1141414112"/>
      </c:barChart>
      <c:dateAx>
        <c:axId val="1141413696"/>
        <c:scaling>
          <c:orientation val="minMax"/>
          <c:max val="44222"/>
          <c:min val="44126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1"/>
                  <a:t>date</a:t>
                </a:r>
                <a:endParaRPr lang="ja-JP" altLang="en-US" sz="1400" b="1"/>
              </a:p>
            </c:rich>
          </c:tx>
          <c:layout>
            <c:manualLayout>
              <c:xMode val="edge"/>
              <c:yMode val="edge"/>
              <c:x val="0.49296975806616228"/>
              <c:y val="0.855305792400574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m/d;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41414112"/>
        <c:crosses val="autoZero"/>
        <c:auto val="1"/>
        <c:lblOffset val="100"/>
        <c:baseTimeUnit val="days"/>
      </c:dateAx>
      <c:valAx>
        <c:axId val="1141414112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baseline="0" dirty="0"/>
                  <a:t>Number of newly infected </a:t>
                </a:r>
                <a:r>
                  <a:rPr lang="en-US" altLang="ja-JP" sz="1000" b="1" i="0" u="none" strike="noStrike" baseline="0" dirty="0">
                    <a:solidFill>
                      <a:srgbClr val="FF0000"/>
                    </a:solidFill>
                  </a:rPr>
                  <a:t>individuals</a:t>
                </a:r>
                <a:endParaRPr lang="ja-JP" altLang="en-US" sz="1000" b="1" dirty="0">
                  <a:solidFill>
                    <a:srgbClr val="FF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1.6162421603054606E-2"/>
              <c:y val="0.104494107365156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4141369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E6E6D7-5E13-4096-99C7-C4F7777588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DAEA2D8-2300-4D9C-994D-4F722BE26A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7CB5B7-1FF5-4865-A3C5-3D9CA1D1B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6A0DDC-11B8-478E-8B23-9C5335926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AB5647-652D-42D9-97E2-9E2C82259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296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13BE0-D271-4B64-82F3-F6B98EAFA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7703F81-9E55-40AC-B18F-8D069B99D1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E77D0F-A2FB-47AD-A0D4-7771E7321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41A778E-CAB9-47B7-9534-3FDC056D6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B3BB9A-4256-4BD6-9CE9-21F1BD37F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565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8BA03BE-6055-434F-B7A7-A6679E3C74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0CF641-5791-4DD3-8E23-6F4178110D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DB355C-0DAC-408B-B6D5-1F063BE1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0A3697-8B13-417D-A4B6-C5DD670B7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66DB33-F1D6-4484-9B12-0B1893364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041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2E7DC9-CD4C-415E-A136-7F52F5C5E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61E962F-B943-4513-B6CF-6049E7B27F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7711C9-21F9-437E-8DF2-D6D52C678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20BBBF-BCD7-4B7C-BD56-661C5808A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9117B6-27A5-4FF8-828E-30AB5CB97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908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48DA65-379A-4048-8644-8DC141E0B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6774D5-E26F-4A31-8307-B4F2D74308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271053-3414-445E-827C-1EAC84107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8F1724-D0C9-4D6E-B46A-C6A3F6BE9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CE199A-7316-4A5B-906F-608AC9143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904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E62021-DB82-4EAF-B68F-6A44BA0C9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C39B05-4AB7-4F3C-ACE6-93E9DBB830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4FAB74D-26D6-4570-9EF1-DB7421D38D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53BF89E-8B13-4585-8CC4-A92D9095A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55AB67-D34C-4DCA-8E0F-1522644BB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33E73E-F878-4DCC-B936-506800745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0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922E4E-02C3-4051-AD26-FA0B4CEFB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84EEA8-BFD0-4C1B-B3C7-6EB865FAD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8F6ED1C-C36E-4939-9068-353A710B2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1AC05D4-CB9B-4020-85BB-E16FEB2A4F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66E03D0-92D7-493B-B29F-D65E219125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631B4EF-D531-4CD5-938C-4A4CD04B6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F671257-D35F-4DB0-B3E8-3952F196C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DD1C05C-5A98-4378-B99B-BE488A95B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994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14EBF1-9B26-443A-989D-05A6BE3CCF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E5A95F6-49BB-465E-8E46-05F24C1C0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D7D07AD-DEC6-46BD-9C96-5820C5423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07D3530-F899-4CF4-9421-115704D5A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362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BBE04AE-2EB0-4EC3-A510-B53AFCB3B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8D3E3DD-F3D5-4E89-A1B2-CD382CA83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060591A-F354-48D9-B24C-E15B5C81A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464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795B02-F193-421E-A1D9-988A2CB08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24E00EF-8BAD-439F-893C-B63931B9FA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CC1504E-1C9C-4E2D-9A9E-038AC079D0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D20CFB-AE08-4971-BA38-1FB7B6960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67558B1-1255-4623-B9F7-A5784C36A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6264472-8358-4BF4-921E-644E15B5F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956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4A77A1-43BB-4FA2-AC65-74DCF9C8B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636DEAC-A4DE-459E-8597-43E27F50AA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3C29A8B-CD26-4600-A700-4CF478C835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19E9352-9942-423A-94E2-E643BD59F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9B4913-D48B-4B3B-B6DC-7EEE3A90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006E375-4881-4679-AE6A-D683FE2C9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781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E4CA618-05AE-4841-8B3A-EF5EA0BE9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1D5978-1A6F-446E-931C-E6CCF69A1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F7A131-8065-4056-8799-5FCD93A243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822BB-449D-4822-9A05-1A5C29219EE5}" type="datetimeFigureOut">
              <a:rPr kumimoji="1" lang="ja-JP" altLang="en-US" smtClean="0"/>
              <a:t>2022/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5F9C04-B4C3-40C3-8AC7-5E530B52DA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07168D-EA02-4335-839F-36C0FCC7FB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E4DD6-4199-4905-8B4D-017841356C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15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5E0920-5860-43C3-8E2A-CD4F6F100F09}"/>
              </a:ext>
            </a:extLst>
          </p:cNvPr>
          <p:cNvSpPr txBox="1"/>
          <p:nvPr/>
        </p:nvSpPr>
        <p:spPr>
          <a:xfrm>
            <a:off x="1932184" y="4575095"/>
            <a:ext cx="7886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the number of newly infected </a:t>
            </a:r>
            <a:r>
              <a:rPr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0" i="0" dirty="0">
                <a:effectLst/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ARS-CoV-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Izumo 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city </a:t>
            </a:r>
            <a:r>
              <a:rPr lang="en-US" altLang="ja-JP" sz="1800" kern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rom </a:t>
            </a:r>
            <a:r>
              <a:rPr lang="en-US" altLang="ja-JP" sz="18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ctober 22, 2020 to January 16, 2021 (“Infection status in the city,</a:t>
            </a:r>
            <a:r>
              <a:rPr lang="en-US" altLang="ja-JP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” Izumo City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ice</a:t>
            </a:r>
            <a:r>
              <a:rPr lang="en-US" altLang="ja-JP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Mar 1, 2021</a:t>
            </a:r>
            <a:r>
              <a:rPr lang="en-US" altLang="ja-JP" sz="18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3FC1967-EAE8-4AE2-8532-8D0332996F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1260389"/>
              </p:ext>
            </p:extLst>
          </p:nvPr>
        </p:nvGraphicFramePr>
        <p:xfrm>
          <a:off x="1914458" y="794480"/>
          <a:ext cx="7664257" cy="3484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67744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4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野 靖久</dc:creator>
  <cp:lastModifiedBy>Author</cp:lastModifiedBy>
  <cp:revision>12</cp:revision>
  <dcterms:created xsi:type="dcterms:W3CDTF">2021-04-09T12:13:12Z</dcterms:created>
  <dcterms:modified xsi:type="dcterms:W3CDTF">2022-01-04T19:56:23Z</dcterms:modified>
</cp:coreProperties>
</file>